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D39B45-9880-4FA0-A296-154D88487DA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45463-B4E4-443C-A293-FADC544D57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CE6A21-5D74-43BC-A37B-9DB769F78B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BC6BD-AF5B-49CD-9D90-7F38B287DC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BE1B80-7920-4E49-A603-A849F67725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92B093-8C68-4A81-882E-67A2F4724A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6174C-06E2-4C4D-A231-5EEB888146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1CCFF-F129-46FA-9C6E-AACCEE01B7C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2EF344-A22E-47ED-9EDF-DF70ADD9E6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D22E24-14F6-4E73-82D8-17A018E566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D35DFB-C265-4933-AFD3-C241C53E62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9DCB8-44BE-4B1B-9961-CD65146638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CC32EC6-D20D-448E-BC47-A7C0FFC19AE5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4992AEB-EEBE-4750-B92F-AA39FBA14F0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95280" y="1700280"/>
            <a:ext cx="4132440" cy="331308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4686480" y="1700280"/>
            <a:ext cx="3989160" cy="3241440"/>
          </a:xfrm>
          <a:prstGeom prst="rect">
            <a:avLst/>
          </a:prstGeom>
          <a:ln w="0">
            <a:noFill/>
          </a:ln>
        </p:spPr>
      </p:pic>
      <p:sp>
        <p:nvSpPr>
          <p:cNvPr id="43" name="TextBox 8"/>
          <p:cNvSpPr/>
          <p:nvPr/>
        </p:nvSpPr>
        <p:spPr>
          <a:xfrm>
            <a:off x="326880" y="155736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A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9"/>
          <p:cNvSpPr/>
          <p:nvPr/>
        </p:nvSpPr>
        <p:spPr>
          <a:xfrm>
            <a:off x="4575600" y="1568520"/>
            <a:ext cx="390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</a:rPr>
              <a:t>(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4"/>
          <p:cNvSpPr/>
          <p:nvPr/>
        </p:nvSpPr>
        <p:spPr>
          <a:xfrm>
            <a:off x="293400" y="214200"/>
            <a:ext cx="237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Figure S1, Oladipo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Picture 2" descr=""/>
          <p:cNvPicPr/>
          <p:nvPr/>
        </p:nvPicPr>
        <p:blipFill>
          <a:blip r:embed="rId1"/>
          <a:stretch/>
        </p:blipFill>
        <p:spPr>
          <a:xfrm>
            <a:off x="1595520" y="1557360"/>
            <a:ext cx="4705200" cy="3959280"/>
          </a:xfrm>
          <a:prstGeom prst="rect">
            <a:avLst/>
          </a:prstGeom>
          <a:ln w="0">
            <a:noFill/>
          </a:ln>
        </p:spPr>
      </p:pic>
      <p:sp>
        <p:nvSpPr>
          <p:cNvPr id="47" name="TextBox 4"/>
          <p:cNvSpPr/>
          <p:nvPr/>
        </p:nvSpPr>
        <p:spPr>
          <a:xfrm>
            <a:off x="475920" y="549360"/>
            <a:ext cx="237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Figure S2, Oladipo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285840" y="1612800"/>
          <a:ext cx="8572320" cy="2390760"/>
        </p:xfrm>
        <a:graphic>
          <a:graphicData uri="http://schemas.openxmlformats.org/drawingml/2006/table">
            <a:tbl>
              <a:tblPr/>
              <a:tblGrid>
                <a:gridCol w="1809720"/>
                <a:gridCol w="1128600"/>
                <a:gridCol w="1123920"/>
                <a:gridCol w="1127160"/>
                <a:gridCol w="1128600"/>
                <a:gridCol w="1125720"/>
                <a:gridCol w="1128600"/>
              </a:tblGrid>
              <a:tr h="320760"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 gridSpan="2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            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XCR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     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XCR2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          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CXCL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760320"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Immunoreactivity  scores (IRS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rmal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17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Maligna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210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rmal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148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Maligna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18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Normal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159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Malignan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Epithelium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n=213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</a:tr>
              <a:tr h="433440"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Absent/wea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49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27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8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13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34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8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9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72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45.3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30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14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</a:tr>
              <a:tr h="425520"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Moderate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8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71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60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76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85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57.4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0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63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86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54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62 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76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</a:tr>
              <a:tr h="450720"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Strong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 </a:t>
                      </a: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1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2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10.5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2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8.1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5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27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1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0.6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  <a:tc>
                  <a:txBody>
                    <a:bodyPr lIns="90000" rIns="90000" tIns="45000" bIns="450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Calibri"/>
                          <a:ea typeface="Arial"/>
                        </a:rPr>
                        <a:t>(9.9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dbeef4"/>
                    </a:solidFill>
                  </a:tcPr>
                </a:tc>
              </a:tr>
            </a:tbl>
          </a:graphicData>
        </a:graphic>
      </p:graphicFrame>
      <p:sp>
        <p:nvSpPr>
          <p:cNvPr id="49" name="TextBox 4"/>
          <p:cNvSpPr/>
          <p:nvPr/>
        </p:nvSpPr>
        <p:spPr>
          <a:xfrm>
            <a:off x="288000" y="214200"/>
            <a:ext cx="2302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Calibri"/>
              </a:rPr>
              <a:t>Table S1, Oladipo et a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53"/>
          <p:cNvSpPr/>
          <p:nvPr/>
        </p:nvSpPr>
        <p:spPr>
          <a:xfrm>
            <a:off x="250920" y="894240"/>
            <a:ext cx="81374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400" spc="-1" strike="noStrike">
                <a:solidFill>
                  <a:srgbClr val="000000"/>
                </a:solidFill>
                <a:latin typeface="Arial"/>
              </a:rPr>
              <a:t>Comparison of CXC-chemokine biomarker expression in malignant and adjacent normal colorectal epitheliu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8" descr=""/>
          <p:cNvPicPr/>
          <p:nvPr/>
        </p:nvPicPr>
        <p:blipFill>
          <a:blip r:embed="rId1"/>
          <a:stretch/>
        </p:blipFill>
        <p:spPr>
          <a:xfrm>
            <a:off x="2514600" y="1523880"/>
            <a:ext cx="3949560" cy="3006720"/>
          </a:xfrm>
          <a:prstGeom prst="rect">
            <a:avLst/>
          </a:prstGeom>
          <a:ln w="0">
            <a:noFill/>
          </a:ln>
        </p:spPr>
      </p:pic>
      <p:sp>
        <p:nvSpPr>
          <p:cNvPr id="52" name="Rectangle 9"/>
          <p:cNvSpPr/>
          <p:nvPr/>
        </p:nvSpPr>
        <p:spPr>
          <a:xfrm>
            <a:off x="755640" y="404640"/>
            <a:ext cx="7848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Table S2, Oladip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orrelation between CXCR1, CXCR2 and CXCL1 expression within CRC tissu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31T14:25:41Z</dcterms:created>
  <dc:creator>DAVID</dc:creator>
  <dc:description/>
  <dc:language>en-US</dc:language>
  <cp:lastModifiedBy>QUB</cp:lastModifiedBy>
  <dcterms:modified xsi:type="dcterms:W3CDTF">2010-11-11T09:00:03Z</dcterms:modified>
  <cp:revision>119</cp:revision>
  <dc:subject/>
  <dc:title>Slide 1</dc:title>
</cp:coreProperties>
</file>